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2" autoAdjust="0"/>
  </p:normalViewPr>
  <p:slideViewPr>
    <p:cSldViewPr snapToGrid="0">
      <p:cViewPr varScale="1">
        <p:scale>
          <a:sx n="107" d="100"/>
          <a:sy n="107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DAF5F-6BA6-4367-A89F-B4D94CF66ACE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5E913D-EA7E-447A-82DF-ABB599A9C1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451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5E913D-EA7E-447A-82DF-ABB599A9C1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6151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92C8D7-346F-1B4A-A89D-C88EFEEDB1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50628F-E16A-BB48-A671-5AAE99E749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58FB75-EBA2-A54E-AB71-EB8FD1DD2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5C5DD-FD68-3C46-AA62-B7E882D2934B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1BF77-EF37-6A4C-A1BD-2C752750B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42A3DF-3383-3941-B8D7-8039B3CE5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0DB4F-F1A2-274F-8619-20CA1A74F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328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70CEAA-F8BA-494D-9A76-CBE4AB897D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7A2860-5EB6-7F4B-BD21-7CF8626F9A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3077FB-3C0F-574E-9BBD-F0578BB74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5C5DD-FD68-3C46-AA62-B7E882D2934B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E4ACAF-1AE9-844B-9DD9-92B1C34A85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A066F7-5045-7F47-AD15-26EF2D8339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0DB4F-F1A2-274F-8619-20CA1A74F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200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ight Arrow 4">
            <a:extLst>
              <a:ext uri="{FF2B5EF4-FFF2-40B4-BE49-F238E27FC236}">
                <a16:creationId xmlns:a16="http://schemas.microsoft.com/office/drawing/2014/main" id="{B048F96A-2893-A543-BBF3-283448DAAE15}"/>
              </a:ext>
            </a:extLst>
          </p:cNvPr>
          <p:cNvSpPr/>
          <p:nvPr/>
        </p:nvSpPr>
        <p:spPr>
          <a:xfrm>
            <a:off x="1029346" y="3690365"/>
            <a:ext cx="9057919" cy="20730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600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FC5D8E3-5E2E-6F40-939C-1F5D84670DBE}"/>
              </a:ext>
            </a:extLst>
          </p:cNvPr>
          <p:cNvCxnSpPr>
            <a:cxnSpLocks/>
          </p:cNvCxnSpPr>
          <p:nvPr/>
        </p:nvCxnSpPr>
        <p:spPr>
          <a:xfrm flipH="1" flipV="1">
            <a:off x="1033922" y="3095565"/>
            <a:ext cx="24941" cy="1142557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F68B08DC-1916-AC4C-98E6-A8B2245A24FA}"/>
              </a:ext>
            </a:extLst>
          </p:cNvPr>
          <p:cNvSpPr txBox="1"/>
          <p:nvPr/>
        </p:nvSpPr>
        <p:spPr>
          <a:xfrm>
            <a:off x="371078" y="2087136"/>
            <a:ext cx="1417355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articipants sign up for DARE Training and complete </a:t>
            </a:r>
          </a:p>
          <a:p>
            <a:pPr algn="ctr"/>
            <a:r>
              <a:rPr lang="en-US" sz="1200" dirty="0"/>
              <a:t>Pre-Training Assessment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BFE02A-5ACB-7340-B74D-9B17509CC870}"/>
              </a:ext>
            </a:extLst>
          </p:cNvPr>
          <p:cNvSpPr txBox="1"/>
          <p:nvPr/>
        </p:nvSpPr>
        <p:spPr>
          <a:xfrm>
            <a:off x="3024404" y="2229781"/>
            <a:ext cx="402336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fter completing pre-training assessment, participants are given access to the videotaped didactic presentation. </a:t>
            </a:r>
          </a:p>
          <a:p>
            <a:pPr algn="ctr"/>
            <a:r>
              <a:rPr lang="en-US" sz="1200" dirty="0"/>
              <a:t>They have two weeks to complete this video at a time convenient to them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CC7580A-0D97-D44A-A169-2EC276C5A63C}"/>
              </a:ext>
            </a:extLst>
          </p:cNvPr>
          <p:cNvSpPr txBox="1"/>
          <p:nvPr/>
        </p:nvSpPr>
        <p:spPr>
          <a:xfrm>
            <a:off x="371078" y="361458"/>
            <a:ext cx="11382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/>
              <a:t>DARE Training Timelin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97B51DA-1904-3A4D-B0A5-2D8BA0CA8B97}"/>
              </a:ext>
            </a:extLst>
          </p:cNvPr>
          <p:cNvSpPr txBox="1"/>
          <p:nvPr/>
        </p:nvSpPr>
        <p:spPr>
          <a:xfrm>
            <a:off x="723173" y="4463782"/>
            <a:ext cx="8042120" cy="40011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2 weeks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02CF0C7-BA43-E14F-8D54-DC7352BE40DF}"/>
              </a:ext>
            </a:extLst>
          </p:cNvPr>
          <p:cNvCxnSpPr>
            <a:cxnSpLocks/>
          </p:cNvCxnSpPr>
          <p:nvPr/>
        </p:nvCxnSpPr>
        <p:spPr>
          <a:xfrm flipV="1">
            <a:off x="9013305" y="2967370"/>
            <a:ext cx="0" cy="1290106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F29F601-7B7F-3240-8177-8677F83D0D44}"/>
              </a:ext>
            </a:extLst>
          </p:cNvPr>
          <p:cNvCxnSpPr>
            <a:cxnSpLocks/>
          </p:cNvCxnSpPr>
          <p:nvPr/>
        </p:nvCxnSpPr>
        <p:spPr>
          <a:xfrm flipV="1">
            <a:off x="10071307" y="2978744"/>
            <a:ext cx="0" cy="174813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1BE3730-71E8-8742-9227-A521E3D4A5A8}"/>
              </a:ext>
            </a:extLst>
          </p:cNvPr>
          <p:cNvSpPr txBox="1"/>
          <p:nvPr/>
        </p:nvSpPr>
        <p:spPr>
          <a:xfrm>
            <a:off x="8309562" y="2147747"/>
            <a:ext cx="125131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articipants attend virtual  synchronous workshop.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F97811F-A507-BF42-A2AB-EA184B37CD4E}"/>
              </a:ext>
            </a:extLst>
          </p:cNvPr>
          <p:cNvSpPr txBox="1"/>
          <p:nvPr/>
        </p:nvSpPr>
        <p:spPr>
          <a:xfrm>
            <a:off x="9687350" y="2140855"/>
            <a:ext cx="2066688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mmediately after completing workshop, participants are asked to complete Post-Training Assessment.</a:t>
            </a:r>
          </a:p>
        </p:txBody>
      </p:sp>
      <p:sp>
        <p:nvSpPr>
          <p:cNvPr id="12" name="Left Brace 11">
            <a:extLst>
              <a:ext uri="{FF2B5EF4-FFF2-40B4-BE49-F238E27FC236}">
                <a16:creationId xmlns:a16="http://schemas.microsoft.com/office/drawing/2014/main" id="{45CF9E8D-3041-BCB9-02EC-9E4C31BA2248}"/>
              </a:ext>
            </a:extLst>
          </p:cNvPr>
          <p:cNvSpPr/>
          <p:nvPr/>
        </p:nvSpPr>
        <p:spPr>
          <a:xfrm rot="5400000">
            <a:off x="4459080" y="-238014"/>
            <a:ext cx="1185970" cy="7766306"/>
          </a:xfrm>
          <a:prstGeom prst="leftBrace">
            <a:avLst>
              <a:gd name="adj1" fmla="val 8333"/>
              <a:gd name="adj2" fmla="val 49843"/>
            </a:avLst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ED59D77-910B-E464-A4B6-1CC791B385EB}"/>
              </a:ext>
            </a:extLst>
          </p:cNvPr>
          <p:cNvSpPr txBox="1"/>
          <p:nvPr/>
        </p:nvSpPr>
        <p:spPr>
          <a:xfrm>
            <a:off x="404520" y="1184336"/>
            <a:ext cx="1138295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This timeline can be used by individuals implementing the DARE training to outline the timing to execute the full curriculum, from the date a participant signs up for training to the completion of the post-training assessment. </a:t>
            </a:r>
          </a:p>
        </p:txBody>
      </p:sp>
    </p:spTree>
    <p:extLst>
      <p:ext uri="{BB962C8B-B14F-4D97-AF65-F5344CB8AC3E}">
        <p14:creationId xmlns:p14="http://schemas.microsoft.com/office/powerpoint/2010/main" val="2189665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104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eidman, Jessica A.,MD</dc:creator>
  <cp:lastModifiedBy>Jessica Zeidman</cp:lastModifiedBy>
  <cp:revision>5</cp:revision>
  <dcterms:created xsi:type="dcterms:W3CDTF">2023-05-01T18:22:34Z</dcterms:created>
  <dcterms:modified xsi:type="dcterms:W3CDTF">2023-05-02T02:53:17Z</dcterms:modified>
</cp:coreProperties>
</file>